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wmf" ContentType="image/x-wmf"/>
  <Override PartName="/ppt/media/image13.wmf" ContentType="image/x-wmf"/>
  <Override PartName="/ppt/media/image8.wmf" ContentType="image/x-wmf"/>
  <Override PartName="/ppt/media/image16.wmf" ContentType="image/x-wmf"/>
  <Override PartName="/ppt/media/image15.wmf" ContentType="image/x-wmf"/>
  <Override PartName="/ppt/media/image14.wmf" ContentType="image/x-wmf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10.png" ContentType="image/png"/>
  <Override PartName="/ppt/media/image5.wmf" ContentType="image/x-wmf"/>
  <Override PartName="/ppt/media/image11.png" ContentType="image/png"/>
  <Override PartName="/ppt/media/image6.wmf" ContentType="image/x-wmf"/>
  <Override PartName="/ppt/media/image7.wmf" ContentType="image/x-wmf"/>
  <Override PartName="/ppt/media/image12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1BC42-6753-4CF7-97E2-F1A8A0EAD9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DE0EA-DFF4-4257-A6E0-2B27F9DB126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82FCC6-E283-4ECF-A07E-FEC9311D6CA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A53CE-D286-493B-B7AC-1EBB5E3CA8D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398DB-9AFF-4A83-80BB-9D965DEA27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F0D30D-B44B-446B-8B44-A6A90836BF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EF5402-4720-416E-AED7-D2DE4EF04E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634E9-06E0-4922-8AA6-783B076850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A2C4D8-56DA-46F6-8E70-8731BD9A188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426F0-83AA-479F-9884-85CBE6DFD2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ED7F83-EF91-42C6-A842-1CEEC106A6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0B4965-BFBE-4409-8822-EF5B02ADAE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I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EC53B25-6812-41CE-B6EA-1C6CBFCE0C1A}" type="slidenum">
              <a:rPr b="0" lang="en-I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7.wmf"/><Relationship Id="rId2" Type="http://schemas.openxmlformats.org/officeDocument/2006/relationships/image" Target="../media/image8.wmf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9.wmf"/><Relationship Id="rId2" Type="http://schemas.openxmlformats.org/officeDocument/2006/relationships/image" Target="../media/image10.png"/><Relationship Id="rId3" Type="http://schemas.openxmlformats.org/officeDocument/2006/relationships/image" Target="../media/image11.png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wmf"/><Relationship Id="rId2" Type="http://schemas.openxmlformats.org/officeDocument/2006/relationships/image" Target="../media/image13.wmf"/><Relationship Id="rId3" Type="http://schemas.openxmlformats.org/officeDocument/2006/relationships/image" Target="../media/image14.wmf"/><Relationship Id="rId4" Type="http://schemas.openxmlformats.org/officeDocument/2006/relationships/image" Target="../media/image15.wmf"/><Relationship Id="rId5" Type="http://schemas.openxmlformats.org/officeDocument/2006/relationships/image" Target="../media/image16.wmf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3" descr=""/>
          <p:cNvPicPr/>
          <p:nvPr/>
        </p:nvPicPr>
        <p:blipFill>
          <a:blip r:embed="rId1"/>
          <a:stretch/>
        </p:blipFill>
        <p:spPr>
          <a:xfrm>
            <a:off x="301680" y="333360"/>
            <a:ext cx="2247840" cy="11541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4" descr=""/>
          <p:cNvPicPr/>
          <p:nvPr/>
        </p:nvPicPr>
        <p:blipFill>
          <a:blip r:embed="rId2"/>
          <a:stretch/>
        </p:blipFill>
        <p:spPr>
          <a:xfrm>
            <a:off x="2549520" y="333360"/>
            <a:ext cx="2238480" cy="11588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3"/>
          <a:stretch/>
        </p:blipFill>
        <p:spPr>
          <a:xfrm>
            <a:off x="301680" y="1460520"/>
            <a:ext cx="2184480" cy="1123920"/>
          </a:xfrm>
          <a:prstGeom prst="rect">
            <a:avLst/>
          </a:prstGeom>
          <a:ln w="0">
            <a:noFill/>
          </a:ln>
        </p:spPr>
      </p:pic>
      <p:sp>
        <p:nvSpPr>
          <p:cNvPr id="44" name="TextBox 9"/>
          <p:cNvSpPr/>
          <p:nvPr/>
        </p:nvSpPr>
        <p:spPr>
          <a:xfrm>
            <a:off x="138240" y="284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10"/>
          <p:cNvSpPr/>
          <p:nvPr/>
        </p:nvSpPr>
        <p:spPr>
          <a:xfrm>
            <a:off x="138240" y="27241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11"/>
          <p:cNvSpPr/>
          <p:nvPr/>
        </p:nvSpPr>
        <p:spPr>
          <a:xfrm>
            <a:off x="4814280" y="284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7" name="Picture 7" descr=""/>
          <p:cNvPicPr/>
          <p:nvPr/>
        </p:nvPicPr>
        <p:blipFill>
          <a:blip r:embed="rId4"/>
          <a:stretch/>
        </p:blipFill>
        <p:spPr>
          <a:xfrm>
            <a:off x="2549520" y="1460520"/>
            <a:ext cx="2238480" cy="1155600"/>
          </a:xfrm>
          <a:prstGeom prst="rect">
            <a:avLst/>
          </a:prstGeom>
          <a:ln w="0">
            <a:noFill/>
          </a:ln>
        </p:spPr>
      </p:pic>
      <p:sp>
        <p:nvSpPr>
          <p:cNvPr id="48" name="TextBox 12"/>
          <p:cNvSpPr/>
          <p:nvPr/>
        </p:nvSpPr>
        <p:spPr>
          <a:xfrm>
            <a:off x="7854480" y="652464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A-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Picture 2" descr=""/>
          <p:cNvPicPr/>
          <p:nvPr/>
        </p:nvPicPr>
        <p:blipFill>
          <a:blip r:embed="rId5"/>
          <a:stretch/>
        </p:blipFill>
        <p:spPr>
          <a:xfrm>
            <a:off x="214200" y="3174840"/>
            <a:ext cx="5726160" cy="31435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3" descr=""/>
          <p:cNvPicPr/>
          <p:nvPr/>
        </p:nvPicPr>
        <p:blipFill>
          <a:blip r:embed="rId6"/>
          <a:stretch/>
        </p:blipFill>
        <p:spPr>
          <a:xfrm>
            <a:off x="5189400" y="304920"/>
            <a:ext cx="5143680" cy="6384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2" descr=""/>
          <p:cNvPicPr/>
          <p:nvPr/>
        </p:nvPicPr>
        <p:blipFill>
          <a:blip r:embed="rId1"/>
          <a:stretch/>
        </p:blipFill>
        <p:spPr>
          <a:xfrm>
            <a:off x="1743120" y="2000160"/>
            <a:ext cx="3000240" cy="1857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2" name="Picture 3" descr=""/>
          <p:cNvPicPr/>
          <p:nvPr/>
        </p:nvPicPr>
        <p:blipFill>
          <a:blip r:embed="rId2"/>
          <a:stretch/>
        </p:blipFill>
        <p:spPr>
          <a:xfrm>
            <a:off x="4857840" y="2000160"/>
            <a:ext cx="2857320" cy="18576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3" name="TextBox 117"/>
          <p:cNvSpPr/>
          <p:nvPr/>
        </p:nvSpPr>
        <p:spPr>
          <a:xfrm>
            <a:off x="1658880" y="16732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119"/>
          <p:cNvSpPr/>
          <p:nvPr/>
        </p:nvSpPr>
        <p:spPr>
          <a:xfrm>
            <a:off x="7744320" y="6453360"/>
            <a:ext cx="95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1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5" name="Group 4"/>
          <p:cNvGrpSpPr/>
          <p:nvPr/>
        </p:nvGrpSpPr>
        <p:grpSpPr>
          <a:xfrm>
            <a:off x="146160" y="189000"/>
            <a:ext cx="8458200" cy="5867280"/>
            <a:chOff x="146160" y="189000"/>
            <a:chExt cx="8458200" cy="5867280"/>
          </a:xfrm>
        </p:grpSpPr>
        <p:pic>
          <p:nvPicPr>
            <p:cNvPr id="56" name="Picture 3" descr=""/>
            <p:cNvPicPr/>
            <p:nvPr/>
          </p:nvPicPr>
          <p:blipFill>
            <a:blip r:embed="rId1"/>
            <a:stretch/>
          </p:blipFill>
          <p:spPr>
            <a:xfrm>
              <a:off x="146160" y="198360"/>
              <a:ext cx="5224320" cy="5857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7" name="Group 3"/>
            <p:cNvGrpSpPr/>
            <p:nvPr/>
          </p:nvGrpSpPr>
          <p:grpSpPr>
            <a:xfrm>
              <a:off x="5495400" y="554400"/>
              <a:ext cx="3108960" cy="4132080"/>
              <a:chOff x="5495400" y="554400"/>
              <a:chExt cx="3108960" cy="4132080"/>
            </a:xfrm>
          </p:grpSpPr>
          <p:sp>
            <p:nvSpPr>
              <p:cNvPr id="58" name="Rectangle 5"/>
              <p:cNvSpPr/>
              <p:nvPr/>
            </p:nvSpPr>
            <p:spPr>
              <a:xfrm rot="16200000">
                <a:off x="5304960" y="1368360"/>
                <a:ext cx="654480" cy="243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Control</a:t>
                </a:r>
                <a:endParaRPr b="0" lang="en-US" sz="16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59" name="Group 12"/>
              <p:cNvGrpSpPr/>
              <p:nvPr/>
            </p:nvGrpSpPr>
            <p:grpSpPr>
              <a:xfrm>
                <a:off x="5752800" y="554400"/>
                <a:ext cx="2851560" cy="2043000"/>
                <a:chOff x="5752800" y="554400"/>
                <a:chExt cx="2851560" cy="2043000"/>
              </a:xfrm>
            </p:grpSpPr>
            <p:pic>
              <p:nvPicPr>
                <p:cNvPr id="60" name="Picture 7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5760720" y="560520"/>
                  <a:ext cx="2835720" cy="2028960"/>
                </a:xfrm>
                <a:prstGeom prst="rect">
                  <a:avLst/>
                </a:prstGeom>
                <a:ln w="0">
                  <a:noFill/>
                </a:ln>
              </p:spPr>
            </p:pic>
            <p:sp>
              <p:nvSpPr>
                <p:cNvPr id="61" name="Freeform 8"/>
                <p:cNvSpPr/>
                <p:nvPr/>
              </p:nvSpPr>
              <p:spPr>
                <a:xfrm>
                  <a:off x="5752800" y="554400"/>
                  <a:ext cx="2851560" cy="2043000"/>
                </a:xfrm>
                <a:custGeom>
                  <a:avLst/>
                  <a:gdLst>
                    <a:gd name="textAreaLeft" fmla="*/ 0 w 2851560"/>
                    <a:gd name="textAreaRight" fmla="*/ 2851920 w 2851560"/>
                    <a:gd name="textAreaTop" fmla="*/ 0 h 2043000"/>
                    <a:gd name="textAreaBottom" fmla="*/ 2043360 h 2043000"/>
                  </a:gdLst>
                  <a:ahLst/>
                  <a:rect l="textAreaLeft" t="textAreaTop" r="textAreaRight" b="textAreaBottom"/>
                  <a:pathLst>
                    <a:path w="6384" h="4576">
                      <a:moveTo>
                        <a:pt x="0" y="8"/>
                      </a:moveTo>
                      <a:cubicBezTo>
                        <a:pt x="0" y="4"/>
                        <a:pt x="4" y="0"/>
                        <a:pt x="8" y="0"/>
                      </a:cubicBezTo>
                      <a:lnTo>
                        <a:pt x="6376" y="0"/>
                      </a:lnTo>
                      <a:cubicBezTo>
                        <a:pt x="6381" y="0"/>
                        <a:pt x="6384" y="4"/>
                        <a:pt x="6384" y="8"/>
                      </a:cubicBezTo>
                      <a:lnTo>
                        <a:pt x="6384" y="4568"/>
                      </a:lnTo>
                      <a:cubicBezTo>
                        <a:pt x="6384" y="4573"/>
                        <a:pt x="6381" y="4576"/>
                        <a:pt x="6376" y="4576"/>
                      </a:cubicBezTo>
                      <a:lnTo>
                        <a:pt x="8" y="4576"/>
                      </a:lnTo>
                      <a:cubicBezTo>
                        <a:pt x="4" y="4576"/>
                        <a:pt x="0" y="4573"/>
                        <a:pt x="0" y="4568"/>
                      </a:cubicBezTo>
                      <a:lnTo>
                        <a:pt x="0" y="8"/>
                      </a:lnTo>
                      <a:close/>
                      <a:moveTo>
                        <a:pt x="16" y="4568"/>
                      </a:moveTo>
                      <a:lnTo>
                        <a:pt x="8" y="4560"/>
                      </a:lnTo>
                      <a:lnTo>
                        <a:pt x="6376" y="4560"/>
                      </a:lnTo>
                      <a:lnTo>
                        <a:pt x="6368" y="4568"/>
                      </a:lnTo>
                      <a:lnTo>
                        <a:pt x="6368" y="8"/>
                      </a:lnTo>
                      <a:lnTo>
                        <a:pt x="6376" y="16"/>
                      </a:lnTo>
                      <a:lnTo>
                        <a:pt x="8" y="16"/>
                      </a:lnTo>
                      <a:lnTo>
                        <a:pt x="16" y="8"/>
                      </a:lnTo>
                      <a:lnTo>
                        <a:pt x="16" y="4568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  <p:grpSp>
            <p:nvGrpSpPr>
              <p:cNvPr id="62" name="Group 1"/>
              <p:cNvGrpSpPr/>
              <p:nvPr/>
            </p:nvGrpSpPr>
            <p:grpSpPr>
              <a:xfrm>
                <a:off x="5495400" y="2649600"/>
                <a:ext cx="3108960" cy="2036880"/>
                <a:chOff x="5495400" y="2649600"/>
                <a:chExt cx="3108960" cy="2036880"/>
              </a:xfrm>
            </p:grpSpPr>
            <p:sp>
              <p:nvSpPr>
                <p:cNvPr id="63" name="Rectangle 6"/>
                <p:cNvSpPr/>
                <p:nvPr/>
              </p:nvSpPr>
              <p:spPr>
                <a:xfrm rot="16200000">
                  <a:off x="5481000" y="3517200"/>
                  <a:ext cx="272160" cy="243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6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ES</a:t>
                  </a:r>
                  <a:endParaRPr b="0" lang="en-US" sz="16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grpSp>
              <p:nvGrpSpPr>
                <p:cNvPr id="64" name="Group 11"/>
                <p:cNvGrpSpPr/>
                <p:nvPr/>
              </p:nvGrpSpPr>
              <p:grpSpPr>
                <a:xfrm>
                  <a:off x="5752800" y="2649600"/>
                  <a:ext cx="2851560" cy="2036880"/>
                  <a:chOff x="5752800" y="2649600"/>
                  <a:chExt cx="2851560" cy="2036880"/>
                </a:xfrm>
              </p:grpSpPr>
              <p:pic>
                <p:nvPicPr>
                  <p:cNvPr id="65" name="Picture 9" descr=""/>
                  <p:cNvPicPr/>
                  <p:nvPr/>
                </p:nvPicPr>
                <p:blipFill>
                  <a:blip r:embed="rId3"/>
                  <a:stretch/>
                </p:blipFill>
                <p:spPr>
                  <a:xfrm>
                    <a:off x="5760720" y="2657520"/>
                    <a:ext cx="2835720" cy="2021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sp>
                <p:nvSpPr>
                  <p:cNvPr id="66" name="Freeform 10"/>
                  <p:cNvSpPr/>
                  <p:nvPr/>
                </p:nvSpPr>
                <p:spPr>
                  <a:xfrm>
                    <a:off x="5752800" y="2649600"/>
                    <a:ext cx="2851560" cy="2036880"/>
                  </a:xfrm>
                  <a:custGeom>
                    <a:avLst/>
                    <a:gdLst>
                      <a:gd name="textAreaLeft" fmla="*/ 0 w 2851560"/>
                      <a:gd name="textAreaRight" fmla="*/ 2851920 w 2851560"/>
                      <a:gd name="textAreaTop" fmla="*/ 0 h 2036880"/>
                      <a:gd name="textAreaBottom" fmla="*/ 2037240 h 2036880"/>
                    </a:gdLst>
                    <a:ahLst/>
                    <a:rect l="textAreaLeft" t="textAreaTop" r="textAreaRight" b="textAreaBottom"/>
                    <a:pathLst>
                      <a:path w="6384" h="4560">
                        <a:moveTo>
                          <a:pt x="0" y="8"/>
                        </a:moveTo>
                        <a:cubicBezTo>
                          <a:pt x="0" y="4"/>
                          <a:pt x="4" y="0"/>
                          <a:pt x="8" y="0"/>
                        </a:cubicBezTo>
                        <a:lnTo>
                          <a:pt x="6376" y="0"/>
                        </a:lnTo>
                        <a:cubicBezTo>
                          <a:pt x="6381" y="0"/>
                          <a:pt x="6384" y="4"/>
                          <a:pt x="6384" y="8"/>
                        </a:cubicBezTo>
                        <a:lnTo>
                          <a:pt x="6384" y="4552"/>
                        </a:lnTo>
                        <a:cubicBezTo>
                          <a:pt x="6384" y="4557"/>
                          <a:pt x="6381" y="4560"/>
                          <a:pt x="6376" y="4560"/>
                        </a:cubicBezTo>
                        <a:lnTo>
                          <a:pt x="8" y="4560"/>
                        </a:lnTo>
                        <a:cubicBezTo>
                          <a:pt x="4" y="4560"/>
                          <a:pt x="0" y="4557"/>
                          <a:pt x="0" y="4552"/>
                        </a:cubicBezTo>
                        <a:lnTo>
                          <a:pt x="0" y="8"/>
                        </a:lnTo>
                        <a:close/>
                        <a:moveTo>
                          <a:pt x="16" y="4552"/>
                        </a:moveTo>
                        <a:lnTo>
                          <a:pt x="8" y="4544"/>
                        </a:lnTo>
                        <a:lnTo>
                          <a:pt x="6376" y="4544"/>
                        </a:lnTo>
                        <a:lnTo>
                          <a:pt x="6368" y="4552"/>
                        </a:lnTo>
                        <a:lnTo>
                          <a:pt x="6368" y="8"/>
                        </a:lnTo>
                        <a:lnTo>
                          <a:pt x="6376" y="16"/>
                        </a:lnTo>
                        <a:lnTo>
                          <a:pt x="8" y="16"/>
                        </a:lnTo>
                        <a:lnTo>
                          <a:pt x="16" y="8"/>
                        </a:lnTo>
                        <a:lnTo>
                          <a:pt x="16" y="4552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Calibri"/>
                    </a:endParaRPr>
                  </a:p>
                </p:txBody>
              </p:sp>
            </p:grpSp>
          </p:grpSp>
        </p:grpSp>
        <p:sp>
          <p:nvSpPr>
            <p:cNvPr id="67" name="TextBox 13"/>
            <p:cNvSpPr/>
            <p:nvPr/>
          </p:nvSpPr>
          <p:spPr>
            <a:xfrm>
              <a:off x="5534280" y="21024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14"/>
            <p:cNvSpPr/>
            <p:nvPr/>
          </p:nvSpPr>
          <p:spPr>
            <a:xfrm>
              <a:off x="305280" y="189000"/>
              <a:ext cx="326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9" name="TextBox 15"/>
          <p:cNvSpPr/>
          <p:nvPr/>
        </p:nvSpPr>
        <p:spPr>
          <a:xfrm>
            <a:off x="7600320" y="6581880"/>
            <a:ext cx="113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2A, 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Straight Connector 16"/>
          <p:cNvSpPr/>
          <p:nvPr/>
        </p:nvSpPr>
        <p:spPr>
          <a:xfrm>
            <a:off x="7205760" y="4595760"/>
            <a:ext cx="12952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Straight Connector 17"/>
          <p:cNvSpPr/>
          <p:nvPr/>
        </p:nvSpPr>
        <p:spPr>
          <a:xfrm>
            <a:off x="7191360" y="2500200"/>
            <a:ext cx="129708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Straight Connector 18"/>
          <p:cNvSpPr/>
          <p:nvPr/>
        </p:nvSpPr>
        <p:spPr>
          <a:xfrm>
            <a:off x="4159080" y="2249640"/>
            <a:ext cx="111636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Straight Connector 19"/>
          <p:cNvSpPr/>
          <p:nvPr/>
        </p:nvSpPr>
        <p:spPr>
          <a:xfrm>
            <a:off x="4143240" y="4071960"/>
            <a:ext cx="1116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traight Connector 20"/>
          <p:cNvSpPr/>
          <p:nvPr/>
        </p:nvSpPr>
        <p:spPr>
          <a:xfrm>
            <a:off x="4133880" y="5927760"/>
            <a:ext cx="1116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Straight Connector 21"/>
          <p:cNvSpPr/>
          <p:nvPr/>
        </p:nvSpPr>
        <p:spPr>
          <a:xfrm>
            <a:off x="1598760" y="5916600"/>
            <a:ext cx="1116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Straight Connector 22"/>
          <p:cNvSpPr/>
          <p:nvPr/>
        </p:nvSpPr>
        <p:spPr>
          <a:xfrm>
            <a:off x="1693800" y="4081320"/>
            <a:ext cx="1116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Straight Connector 23"/>
          <p:cNvSpPr/>
          <p:nvPr/>
        </p:nvSpPr>
        <p:spPr>
          <a:xfrm>
            <a:off x="1668600" y="2235240"/>
            <a:ext cx="1116000" cy="14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24"/>
          <p:cNvSpPr/>
          <p:nvPr/>
        </p:nvSpPr>
        <p:spPr>
          <a:xfrm>
            <a:off x="7633800" y="2306520"/>
            <a:ext cx="53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500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Calibri"/>
              </a:rPr>
              <a:t>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25"/>
          <p:cNvSpPr/>
          <p:nvPr/>
        </p:nvSpPr>
        <p:spPr>
          <a:xfrm>
            <a:off x="7614720" y="4405320"/>
            <a:ext cx="53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500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Calibri"/>
              </a:rPr>
              <a:t>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26"/>
          <p:cNvSpPr/>
          <p:nvPr/>
        </p:nvSpPr>
        <p:spPr>
          <a:xfrm>
            <a:off x="4412520" y="5754600"/>
            <a:ext cx="53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500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Calibri"/>
              </a:rPr>
              <a:t>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27"/>
          <p:cNvSpPr/>
          <p:nvPr/>
        </p:nvSpPr>
        <p:spPr>
          <a:xfrm>
            <a:off x="4469040" y="3882960"/>
            <a:ext cx="53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500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Calibri"/>
              </a:rPr>
              <a:t>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28"/>
          <p:cNvSpPr/>
          <p:nvPr/>
        </p:nvSpPr>
        <p:spPr>
          <a:xfrm>
            <a:off x="4477680" y="2065320"/>
            <a:ext cx="53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500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Calibri"/>
              </a:rPr>
              <a:t>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29"/>
          <p:cNvSpPr/>
          <p:nvPr/>
        </p:nvSpPr>
        <p:spPr>
          <a:xfrm>
            <a:off x="1975680" y="2052720"/>
            <a:ext cx="53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500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Calibri"/>
              </a:rPr>
              <a:t>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30"/>
          <p:cNvSpPr/>
          <p:nvPr/>
        </p:nvSpPr>
        <p:spPr>
          <a:xfrm>
            <a:off x="2002680" y="3898800"/>
            <a:ext cx="53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500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Calibri"/>
              </a:rPr>
              <a:t>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TextBox 31"/>
          <p:cNvSpPr/>
          <p:nvPr/>
        </p:nvSpPr>
        <p:spPr>
          <a:xfrm>
            <a:off x="1897200" y="5724360"/>
            <a:ext cx="534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alibri"/>
              </a:rPr>
              <a:t>500 </a:t>
            </a:r>
            <a:r>
              <a:rPr b="0" lang="en-US" sz="900" spc="-1" strike="noStrike">
                <a:solidFill>
                  <a:srgbClr val="000000"/>
                </a:solidFill>
                <a:latin typeface="Calibri"/>
                <a:ea typeface="Calibri"/>
              </a:rPr>
              <a:t>µm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Picture 2" descr=""/>
          <p:cNvPicPr/>
          <p:nvPr/>
        </p:nvPicPr>
        <p:blipFill>
          <a:blip r:embed="rId1"/>
          <a:stretch/>
        </p:blipFill>
        <p:spPr>
          <a:xfrm>
            <a:off x="285840" y="3006720"/>
            <a:ext cx="4240080" cy="162072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3" descr=""/>
          <p:cNvPicPr/>
          <p:nvPr/>
        </p:nvPicPr>
        <p:blipFill>
          <a:blip r:embed="rId2"/>
          <a:stretch/>
        </p:blipFill>
        <p:spPr>
          <a:xfrm>
            <a:off x="4572000" y="3006720"/>
            <a:ext cx="4240080" cy="162072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4" descr=""/>
          <p:cNvPicPr/>
          <p:nvPr/>
        </p:nvPicPr>
        <p:blipFill>
          <a:blip r:embed="rId3"/>
          <a:stretch/>
        </p:blipFill>
        <p:spPr>
          <a:xfrm>
            <a:off x="285840" y="4881600"/>
            <a:ext cx="4240080" cy="161928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5" descr=""/>
          <p:cNvPicPr/>
          <p:nvPr/>
        </p:nvPicPr>
        <p:blipFill>
          <a:blip r:embed="rId4"/>
          <a:stretch/>
        </p:blipFill>
        <p:spPr>
          <a:xfrm>
            <a:off x="4572000" y="4879800"/>
            <a:ext cx="4240080" cy="1619280"/>
          </a:xfrm>
          <a:prstGeom prst="rect">
            <a:avLst/>
          </a:prstGeom>
          <a:ln w="0">
            <a:noFill/>
          </a:ln>
        </p:spPr>
      </p:pic>
      <p:sp>
        <p:nvSpPr>
          <p:cNvPr id="90" name="TextBox 5"/>
          <p:cNvSpPr/>
          <p:nvPr/>
        </p:nvSpPr>
        <p:spPr>
          <a:xfrm>
            <a:off x="2201760" y="2739960"/>
            <a:ext cx="749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s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da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TextBox 6"/>
          <p:cNvSpPr/>
          <p:nvPr/>
        </p:nvSpPr>
        <p:spPr>
          <a:xfrm>
            <a:off x="6432120" y="2751120"/>
            <a:ext cx="803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1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th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da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2" name="TextBox 7"/>
          <p:cNvSpPr/>
          <p:nvPr/>
        </p:nvSpPr>
        <p:spPr>
          <a:xfrm>
            <a:off x="2194920" y="4624560"/>
            <a:ext cx="797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2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s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da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TextBox 8"/>
          <p:cNvSpPr/>
          <p:nvPr/>
        </p:nvSpPr>
        <p:spPr>
          <a:xfrm>
            <a:off x="6437520" y="4622760"/>
            <a:ext cx="797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31</a:t>
            </a:r>
            <a:r>
              <a:rPr b="0" lang="en-US" sz="14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st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da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94" name="Picture 2" descr=""/>
          <p:cNvPicPr/>
          <p:nvPr/>
        </p:nvPicPr>
        <p:blipFill>
          <a:blip r:embed="rId5"/>
          <a:stretch/>
        </p:blipFill>
        <p:spPr>
          <a:xfrm>
            <a:off x="542880" y="285840"/>
            <a:ext cx="3316320" cy="2286000"/>
          </a:xfrm>
          <a:prstGeom prst="rect">
            <a:avLst/>
          </a:prstGeom>
          <a:ln w="0">
            <a:noFill/>
          </a:ln>
        </p:spPr>
      </p:pic>
      <p:sp>
        <p:nvSpPr>
          <p:cNvPr id="95" name="TextBox 11"/>
          <p:cNvSpPr/>
          <p:nvPr/>
        </p:nvSpPr>
        <p:spPr>
          <a:xfrm>
            <a:off x="188280" y="190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TextBox 12"/>
          <p:cNvSpPr/>
          <p:nvPr/>
        </p:nvSpPr>
        <p:spPr>
          <a:xfrm>
            <a:off x="116640" y="271476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7" name="TextBox 13"/>
          <p:cNvSpPr/>
          <p:nvPr/>
        </p:nvSpPr>
        <p:spPr>
          <a:xfrm>
            <a:off x="7814520" y="6543720"/>
            <a:ext cx="109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S3A,B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15T11:35:40Z</dcterms:created>
  <dc:creator>DELL</dc:creator>
  <dc:description/>
  <dc:language>en-US</dc:language>
  <cp:lastModifiedBy>R.Vijitha</cp:lastModifiedBy>
  <dcterms:modified xsi:type="dcterms:W3CDTF">2015-10-30T06:48:47Z</dcterms:modified>
  <cp:revision>21</cp:revision>
  <dc:subject/>
  <dc:title>Slide 1</dc:title>
</cp:coreProperties>
</file>